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7" r:id="rId3"/>
    <p:sldId id="268" r:id="rId4"/>
    <p:sldId id="270" r:id="rId5"/>
    <p:sldId id="27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30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8D3BD8-D467-48B9-8D08-8447998621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5F9F49B-A4EB-4E92-B535-C948A14E29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4E48DE-07BA-4D08-886E-F3F0391BCE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235A8-ED68-4E5E-8ADD-213F9DE27381}" type="datetimeFigureOut">
              <a:rPr lang="en-GB" smtClean="0"/>
              <a:t>11/03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529655-D440-4D8E-BDF8-8B6E58ED7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8AD9A9-7CB2-433B-8DC2-9F4D9AED1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F13B2-33D3-4127-8A37-5B49919B71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7006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B3C3B1-84C9-47F8-B2DF-56B9E935B3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10E7F1-09B1-472A-A8C3-D9F640C427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621F8B-1F1F-4A18-85F9-BDBFDCDD5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235A8-ED68-4E5E-8ADD-213F9DE27381}" type="datetimeFigureOut">
              <a:rPr lang="en-GB" smtClean="0"/>
              <a:t>11/03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399748-CBD9-4696-9D8E-A4ADE060C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00485A-A94B-4422-ABD3-9C20E96254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F13B2-33D3-4127-8A37-5B49919B71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37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4FC9654-9741-4FC5-88EA-77E9394DBC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0FCFFF-A546-4353-A912-8E61895CF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AEABF8-BA00-408A-BF62-24AA4BA9A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235A8-ED68-4E5E-8ADD-213F9DE27381}" type="datetimeFigureOut">
              <a:rPr lang="en-GB" smtClean="0"/>
              <a:t>11/03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B271D2-5A1C-4AE4-A4C2-D90EA68CD9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3340B8-8D29-4DB7-8C3A-78D56A054E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F13B2-33D3-4127-8A37-5B49919B71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643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FC7BA8-3C48-4D33-A4C9-800C077481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86EB51-7D28-4A0E-9065-E5F439BB49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C13442-6803-4940-8D3D-2B4CCDB329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235A8-ED68-4E5E-8ADD-213F9DE27381}" type="datetimeFigureOut">
              <a:rPr lang="en-GB" smtClean="0"/>
              <a:t>11/03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1DC334-8C7D-45B9-A434-C8472CB5DD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2F21C8-7FF6-4B3D-87C4-CA6630D68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F13B2-33D3-4127-8A37-5B49919B71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14757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E6C440-26E5-4992-97DC-A111EB0C41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9B4847-BC43-4AE0-8884-1E567A43AA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E89153-8AB9-48B9-A839-E2E61E0865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235A8-ED68-4E5E-8ADD-213F9DE27381}" type="datetimeFigureOut">
              <a:rPr lang="en-GB" smtClean="0"/>
              <a:t>11/03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C110CA-79B1-4B06-9747-98B656672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96E3B8-D775-4DDA-9BA0-1CD0087DC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F13B2-33D3-4127-8A37-5B49919B71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3354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7EC952-D024-4039-8D3F-00C64A4C01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83B1C3-EAF8-43FE-82C0-2015A7F0E1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8D11B2-9191-42F8-9467-BC42F5352C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405590-E6FE-4CF2-92E7-6375F9BF04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235A8-ED68-4E5E-8ADD-213F9DE27381}" type="datetimeFigureOut">
              <a:rPr lang="en-GB" smtClean="0"/>
              <a:t>11/03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184F17-4A7C-4FDD-A8FE-66C83AB67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67BE4A-CCEF-4C96-84CA-D9F11D6F89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F13B2-33D3-4127-8A37-5B49919B71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58743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EBE4E2-2628-48F8-BF31-7A84AB7C75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F9544D-9C3F-40F1-955F-85E262F96C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9B762D-7156-482B-89CF-754B91FDF8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056AE22-D391-4F43-88F9-84AE6C88F0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7D2E2DA-C21C-43E7-8E86-879E93DEBB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08737B2-EE8E-46FA-A487-53805858C6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235A8-ED68-4E5E-8ADD-213F9DE27381}" type="datetimeFigureOut">
              <a:rPr lang="en-GB" smtClean="0"/>
              <a:t>11/03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6F20A6B-6658-4614-9413-86F34547EB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7DB4529-F962-4324-93DA-F6CD109599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F13B2-33D3-4127-8A37-5B49919B71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4569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D5F23A-3DD9-42F0-A66B-F2DD51D158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62BDBD0-64E2-42C5-9096-4A35EE62C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235A8-ED68-4E5E-8ADD-213F9DE27381}" type="datetimeFigureOut">
              <a:rPr lang="en-GB" smtClean="0"/>
              <a:t>11/03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BE6C634-5FCF-4AD2-86AD-F868015A16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97425D5-8D88-455C-A3CB-651AC3E62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F13B2-33D3-4127-8A37-5B49919B71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6921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CD9E7FE-7584-4B9C-A62C-608D25F4C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235A8-ED68-4E5E-8ADD-213F9DE27381}" type="datetimeFigureOut">
              <a:rPr lang="en-GB" smtClean="0"/>
              <a:t>11/03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2FE0D99-9E2B-4699-8405-609E2523D0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FA90F7-E3B4-4D44-820A-314AAF7C8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F13B2-33D3-4127-8A37-5B49919B71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0386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3BD061-C9A3-48E4-A36C-03E7F72815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46F765-1153-4692-B63A-F33A2E035D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1E5B22-1A2D-4517-AA31-697E8CCD26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9AE88E-6A01-41E9-AA12-454433AC07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235A8-ED68-4E5E-8ADD-213F9DE27381}" type="datetimeFigureOut">
              <a:rPr lang="en-GB" smtClean="0"/>
              <a:t>11/03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6543CA-1FE1-4E79-85C3-2EB5E02265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20B029-308E-495F-A806-FEDE56A738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F13B2-33D3-4127-8A37-5B49919B71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3202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47612D-B0B6-40DB-A7F7-B2FB848DFB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6C19AE6-F12A-4BE8-875E-57376F943E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7CAE1A-0952-4A8B-86EB-2979511F9E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A637D0-DF31-4968-9F30-010B5F8032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235A8-ED68-4E5E-8ADD-213F9DE27381}" type="datetimeFigureOut">
              <a:rPr lang="en-GB" smtClean="0"/>
              <a:t>11/03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54E2EA-635E-4F18-9646-0E11111916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778BE2-659C-4405-9D1B-C5D28ECD4B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F13B2-33D3-4127-8A37-5B49919B71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6960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39F0C8C-A715-48DE-A2A2-F284A9FA0F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284CF4-ED5E-430B-AAEF-9ECD8F7A50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EA59B4-7418-4C4F-A3ED-DD5708C7FF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D235A8-ED68-4E5E-8ADD-213F9DE27381}" type="datetimeFigureOut">
              <a:rPr lang="en-GB" smtClean="0"/>
              <a:t>11/03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212E7C-5EAF-4F52-87D3-C1B1487044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368F98-776B-43C8-BA0C-32E1959DB8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7F13B2-33D3-4127-8A37-5B49919B71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0434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12" Type="http://schemas.openxmlformats.org/officeDocument/2006/relationships/image" Target="../media/image11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emf"/><Relationship Id="rId11" Type="http://schemas.openxmlformats.org/officeDocument/2006/relationships/oleObject" Target="../embeddings/oleObject11.bin"/><Relationship Id="rId5" Type="http://schemas.openxmlformats.org/officeDocument/2006/relationships/oleObject" Target="../embeddings/oleObject8.bin"/><Relationship Id="rId10" Type="http://schemas.openxmlformats.org/officeDocument/2006/relationships/image" Target="../media/image10.emf"/><Relationship Id="rId4" Type="http://schemas.openxmlformats.org/officeDocument/2006/relationships/image" Target="../media/image7.emf"/><Relationship Id="rId9" Type="http://schemas.openxmlformats.org/officeDocument/2006/relationships/oleObject" Target="../embeddings/oleObject10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oleObject" Target="../embeddings/oleObject12.bin"/><Relationship Id="rId7" Type="http://schemas.openxmlformats.org/officeDocument/2006/relationships/oleObject" Target="../embeddings/oleObject14.bin"/><Relationship Id="rId12" Type="http://schemas.openxmlformats.org/officeDocument/2006/relationships/image" Target="../media/image1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3.emf"/><Relationship Id="rId11" Type="http://schemas.openxmlformats.org/officeDocument/2006/relationships/oleObject" Target="../embeddings/oleObject16.bin"/><Relationship Id="rId5" Type="http://schemas.openxmlformats.org/officeDocument/2006/relationships/oleObject" Target="../embeddings/oleObject13.bin"/><Relationship Id="rId10" Type="http://schemas.openxmlformats.org/officeDocument/2006/relationships/image" Target="../media/image15.emf"/><Relationship Id="rId4" Type="http://schemas.openxmlformats.org/officeDocument/2006/relationships/image" Target="../media/image12.emf"/><Relationship Id="rId9" Type="http://schemas.openxmlformats.org/officeDocument/2006/relationships/oleObject" Target="../embeddings/oleObject15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17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27C3009-8713-4051-9528-68D4E27C0A25}"/>
              </a:ext>
            </a:extLst>
          </p:cNvPr>
          <p:cNvSpPr txBox="1"/>
          <p:nvPr/>
        </p:nvSpPr>
        <p:spPr>
          <a:xfrm>
            <a:off x="273580" y="125874"/>
            <a:ext cx="5113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e1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9080515"/>
              </p:ext>
            </p:extLst>
          </p:nvPr>
        </p:nvGraphicFramePr>
        <p:xfrm>
          <a:off x="471437" y="941865"/>
          <a:ext cx="2359076" cy="27705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96" name="Prism 6" r:id="rId3" imgW="3677346" imgH="4317887" progId="Prism6.Document">
                  <p:embed/>
                </p:oleObj>
              </mc:Choice>
              <mc:Fallback>
                <p:oleObj name="Prism 6" r:id="rId3" imgW="3677346" imgH="431788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1437" y="941865"/>
                        <a:ext cx="2359076" cy="27705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874879" y="651212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aximum IgM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133346" y="547080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A</a:t>
            </a:r>
            <a:endParaRPr lang="en-GB" sz="2400" b="1" dirty="0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9284592"/>
              </p:ext>
            </p:extLst>
          </p:nvPr>
        </p:nvGraphicFramePr>
        <p:xfrm>
          <a:off x="3556001" y="941866"/>
          <a:ext cx="2341760" cy="27705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97" name="Prism 6" r:id="rId5" imgW="3649975" imgH="4317887" progId="Prism6.Document">
                  <p:embed/>
                </p:oleObj>
              </mc:Choice>
              <mc:Fallback>
                <p:oleObj name="Prism 6" r:id="rId5" imgW="3649975" imgH="431788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56001" y="941866"/>
                        <a:ext cx="2341760" cy="27705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3889022" y="651212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aximum IgG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3260761" y="547080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B</a:t>
            </a:r>
            <a:endParaRPr lang="en-GB" sz="2400" b="1" dirty="0"/>
          </a:p>
        </p:txBody>
      </p:sp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041580"/>
              </p:ext>
            </p:extLst>
          </p:nvPr>
        </p:nvGraphicFramePr>
        <p:xfrm>
          <a:off x="6645275" y="1035050"/>
          <a:ext cx="2238375" cy="2649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98" name="Prism 6" r:id="rId7" imgW="3649975" imgH="4317887" progId="Prism6.Document">
                  <p:embed/>
                </p:oleObj>
              </mc:Choice>
              <mc:Fallback>
                <p:oleObj name="Prism 6" r:id="rId7" imgW="3649975" imgH="431788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645275" y="1035050"/>
                        <a:ext cx="2238375" cy="2649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6294779" y="547080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C</a:t>
            </a:r>
            <a:endParaRPr lang="en-GB" sz="24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6953080" y="651212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aximum IgG2</a:t>
            </a:r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2566614"/>
              </p:ext>
            </p:extLst>
          </p:nvPr>
        </p:nvGraphicFramePr>
        <p:xfrm>
          <a:off x="9523052" y="989766"/>
          <a:ext cx="2348832" cy="27174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99" name="Prism 6" r:id="rId9" imgW="3732086" imgH="4317887" progId="Prism6.Document">
                  <p:embed/>
                </p:oleObj>
              </mc:Choice>
              <mc:Fallback>
                <p:oleObj name="Prism 6" r:id="rId9" imgW="3732086" imgH="431788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523052" y="989766"/>
                        <a:ext cx="2348832" cy="27174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9868447" y="651212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aximum IgG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9300464" y="547080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D</a:t>
            </a:r>
            <a:endParaRPr lang="en-GB" sz="24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133346" y="3695783"/>
            <a:ext cx="3369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E</a:t>
            </a:r>
            <a:endParaRPr lang="en-GB" sz="2400" b="1" dirty="0"/>
          </a:p>
        </p:txBody>
      </p:sp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6236409"/>
              </p:ext>
            </p:extLst>
          </p:nvPr>
        </p:nvGraphicFramePr>
        <p:xfrm>
          <a:off x="469900" y="4143375"/>
          <a:ext cx="2381250" cy="2754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00" name="Prism 6" r:id="rId11" imgW="3732086" imgH="4317887" progId="Prism6.Document">
                  <p:embed/>
                </p:oleObj>
              </mc:Choice>
              <mc:Fallback>
                <p:oleObj name="Prism 6" r:id="rId11" imgW="3732086" imgH="431788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69900" y="4143375"/>
                        <a:ext cx="2381250" cy="2754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874879" y="3781043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aximum IgG4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3273585" y="3695783"/>
            <a:ext cx="325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F</a:t>
            </a:r>
            <a:endParaRPr lang="en-GB" sz="2400" b="1" dirty="0"/>
          </a:p>
        </p:txBody>
      </p:sp>
      <p:graphicFrame>
        <p:nvGraphicFramePr>
          <p:cNvPr id="19" name="Objec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69475306"/>
              </p:ext>
            </p:extLst>
          </p:nvPr>
        </p:nvGraphicFramePr>
        <p:xfrm>
          <a:off x="3610537" y="4140261"/>
          <a:ext cx="2382682" cy="27637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01" name="Prism 6" r:id="rId13" imgW="3723083" imgH="4317887" progId="Prism6.Document">
                  <p:embed/>
                </p:oleObj>
              </mc:Choice>
              <mc:Fallback>
                <p:oleObj name="Prism 6" r:id="rId13" imgW="3723083" imgH="431788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610537" y="4140261"/>
                        <a:ext cx="2382682" cy="27637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3966487" y="3770358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aximum IgA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455142" y="4157448"/>
            <a:ext cx="541674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/>
              <a:t>Supplementary Figure 1 Maximum circulating immunoglobulin concentrations measured in the first 7 d after stroke</a:t>
            </a:r>
          </a:p>
          <a:p>
            <a:pPr algn="just"/>
            <a:r>
              <a:rPr lang="en-GB" sz="1400" dirty="0"/>
              <a:t>Maximum circulating concentration of IgM, IgG1, IgG2, IgG3, IgG4 and IgA  measured in the first 7 d after stroke were not significantly different in both placebo and IL-1ra treated patients in comparison to healthy controls. Data show mean ±SD, one-way ANOVA with </a:t>
            </a:r>
            <a:r>
              <a:rPr lang="en-GB" sz="1400" dirty="0" err="1"/>
              <a:t>Bonferonni</a:t>
            </a:r>
            <a:r>
              <a:rPr lang="en-GB" sz="1400" dirty="0"/>
              <a:t> correction.</a:t>
            </a:r>
          </a:p>
        </p:txBody>
      </p:sp>
    </p:spTree>
    <p:extLst>
      <p:ext uri="{BB962C8B-B14F-4D97-AF65-F5344CB8AC3E}">
        <p14:creationId xmlns:p14="http://schemas.microsoft.com/office/powerpoint/2010/main" val="32999769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27C3009-8713-4051-9528-68D4E27C0A25}"/>
              </a:ext>
            </a:extLst>
          </p:cNvPr>
          <p:cNvSpPr txBox="1"/>
          <p:nvPr/>
        </p:nvSpPr>
        <p:spPr>
          <a:xfrm>
            <a:off x="273580" y="125874"/>
            <a:ext cx="5113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e2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5113439"/>
              </p:ext>
            </p:extLst>
          </p:nvPr>
        </p:nvGraphicFramePr>
        <p:xfrm>
          <a:off x="502145" y="918434"/>
          <a:ext cx="2274724" cy="2698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78" name="Prism 6" r:id="rId3" imgW="3732086" imgH="4427734" progId="Prism6.Document">
                  <p:embed/>
                </p:oleObj>
              </mc:Choice>
              <mc:Fallback>
                <p:oleObj name="Prism 6" r:id="rId3" imgW="3732086" imgH="4427734" progId="Prism6.Document">
                  <p:embed/>
                  <p:pic>
                    <p:nvPicPr>
                      <p:cNvPr id="21" name="Object 20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2145" y="918434"/>
                        <a:ext cx="2274724" cy="2698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874879" y="651212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aximum C3b/ iC3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133346" y="547080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A</a:t>
            </a:r>
            <a:endParaRPr lang="en-GB" sz="24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3260761" y="547080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B</a:t>
            </a:r>
            <a:endParaRPr lang="en-GB" sz="24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6294779" y="547080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C</a:t>
            </a:r>
            <a:endParaRPr lang="en-GB" sz="24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133346" y="369578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D</a:t>
            </a:r>
            <a:endParaRPr lang="en-GB" sz="24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3273585" y="3695783"/>
            <a:ext cx="3401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E</a:t>
            </a:r>
            <a:endParaRPr lang="en-GB" sz="2400" b="1" dirty="0"/>
          </a:p>
        </p:txBody>
      </p:sp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9817133"/>
              </p:ext>
            </p:extLst>
          </p:nvPr>
        </p:nvGraphicFramePr>
        <p:xfrm>
          <a:off x="3610537" y="918433"/>
          <a:ext cx="2312871" cy="2698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79" name="Prism 6" r:id="rId5" imgW="3732086" imgH="4354262" progId="Prism6.Document">
                  <p:embed/>
                </p:oleObj>
              </mc:Choice>
              <mc:Fallback>
                <p:oleObj name="Prism 6" r:id="rId5" imgW="3732086" imgH="435426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610537" y="918433"/>
                        <a:ext cx="2312871" cy="2698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4037787" y="651212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aximum C3</a:t>
            </a:r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080402"/>
              </p:ext>
            </p:extLst>
          </p:nvPr>
        </p:nvGraphicFramePr>
        <p:xfrm>
          <a:off x="6697997" y="918434"/>
          <a:ext cx="2378271" cy="27748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80" name="Prism 6" r:id="rId7" imgW="3732086" imgH="4354262" progId="Prism6.Document">
                  <p:embed/>
                </p:oleObj>
              </mc:Choice>
              <mc:Fallback>
                <p:oleObj name="Prism 6" r:id="rId7" imgW="3732086" imgH="435426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697997" y="918434"/>
                        <a:ext cx="2378271" cy="27748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7144994" y="653685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aximum C4</a:t>
            </a:r>
          </a:p>
        </p:txBody>
      </p:sp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904355"/>
              </p:ext>
            </p:extLst>
          </p:nvPr>
        </p:nvGraphicFramePr>
        <p:xfrm>
          <a:off x="502145" y="4157448"/>
          <a:ext cx="2221696" cy="26082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81" name="Prism 6" r:id="rId9" imgW="3732086" imgH="4381994" progId="Prism6.Document">
                  <p:embed/>
                </p:oleObj>
              </mc:Choice>
              <mc:Fallback>
                <p:oleObj name="Prism 6" r:id="rId9" imgW="3732086" imgH="438199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02145" y="4157448"/>
                        <a:ext cx="2221696" cy="26082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874879" y="3806584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aximum Factor H</a:t>
            </a:r>
          </a:p>
        </p:txBody>
      </p:sp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6780605"/>
              </p:ext>
            </p:extLst>
          </p:nvPr>
        </p:nvGraphicFramePr>
        <p:xfrm>
          <a:off x="3610537" y="4157448"/>
          <a:ext cx="2205891" cy="26271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82" name="Prism 6" r:id="rId11" imgW="3732086" imgH="4445741" progId="Prism6.Document">
                  <p:embed/>
                </p:oleObj>
              </mc:Choice>
              <mc:Fallback>
                <p:oleObj name="Prism 6" r:id="rId11" imgW="3732086" imgH="444574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610537" y="4157448"/>
                        <a:ext cx="2205891" cy="26271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3992134" y="3806584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aximum </a:t>
            </a:r>
            <a:r>
              <a:rPr lang="en-GB" sz="1600" b="1" dirty="0" err="1"/>
              <a:t>Properdin</a:t>
            </a:r>
            <a:endParaRPr lang="en-GB" sz="16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6455142" y="4157448"/>
            <a:ext cx="541674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/>
              <a:t>Supplementary Figure 2 Maximum circulating complement concentrations not significantly different in the first 7 d after stroke</a:t>
            </a:r>
          </a:p>
          <a:p>
            <a:pPr algn="just"/>
            <a:r>
              <a:rPr lang="en-GB" sz="1400" dirty="0"/>
              <a:t>Maximum circulating concentration of C3b/iC3b, C3, C4, Factor H, and </a:t>
            </a:r>
            <a:r>
              <a:rPr lang="en-GB" sz="1400" dirty="0" err="1"/>
              <a:t>Properdin</a:t>
            </a:r>
            <a:r>
              <a:rPr lang="en-GB" sz="1400" dirty="0"/>
              <a:t>  measured in the first 7 d after stroke were not significantly different in both placebo and IL-1ra treated patients in comparison to healthy controls. Data show mean ±SD, one-way ANOVA with </a:t>
            </a:r>
            <a:r>
              <a:rPr lang="en-GB" sz="1400" dirty="0" err="1"/>
              <a:t>Bonferonni</a:t>
            </a:r>
            <a:r>
              <a:rPr lang="en-GB" sz="1400" dirty="0"/>
              <a:t> correction.</a:t>
            </a:r>
          </a:p>
        </p:txBody>
      </p:sp>
    </p:spTree>
    <p:extLst>
      <p:ext uri="{BB962C8B-B14F-4D97-AF65-F5344CB8AC3E}">
        <p14:creationId xmlns:p14="http://schemas.microsoft.com/office/powerpoint/2010/main" val="31151186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27C3009-8713-4051-9528-68D4E27C0A25}"/>
              </a:ext>
            </a:extLst>
          </p:cNvPr>
          <p:cNvSpPr txBox="1"/>
          <p:nvPr/>
        </p:nvSpPr>
        <p:spPr>
          <a:xfrm>
            <a:off x="273580" y="125874"/>
            <a:ext cx="5113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e3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874879" y="651212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inimum C1q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133346" y="547080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A</a:t>
            </a:r>
            <a:endParaRPr lang="en-GB" sz="24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3260761" y="504550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B</a:t>
            </a:r>
            <a:endParaRPr lang="en-GB" sz="24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6294779" y="547080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C</a:t>
            </a:r>
            <a:endParaRPr lang="en-GB" sz="24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133346" y="369578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D</a:t>
            </a:r>
            <a:endParaRPr lang="en-GB" sz="24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8753ABF-E0E8-40DF-8542-5776092E8010}"/>
              </a:ext>
            </a:extLst>
          </p:cNvPr>
          <p:cNvSpPr txBox="1"/>
          <p:nvPr/>
        </p:nvSpPr>
        <p:spPr>
          <a:xfrm>
            <a:off x="3273585" y="3695783"/>
            <a:ext cx="3401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E</a:t>
            </a:r>
            <a:endParaRPr lang="en-GB" sz="24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4037787" y="651212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inimum C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7144994" y="653685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inimum C9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874879" y="3806584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inimum C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D860492-275C-4328-8C20-B0048610B39F}"/>
              </a:ext>
            </a:extLst>
          </p:cNvPr>
          <p:cNvSpPr txBox="1"/>
          <p:nvPr/>
        </p:nvSpPr>
        <p:spPr>
          <a:xfrm>
            <a:off x="3992134" y="3806584"/>
            <a:ext cx="1931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/>
              <a:t>Minimum C4b</a:t>
            </a:r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6084240"/>
              </p:ext>
            </p:extLst>
          </p:nvPr>
        </p:nvGraphicFramePr>
        <p:xfrm>
          <a:off x="595048" y="989766"/>
          <a:ext cx="2235465" cy="26082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6" name="Prism 6" r:id="rId3" imgW="3732086" imgH="4354262" progId="Prism6.Document">
                  <p:embed/>
                </p:oleObj>
              </mc:Choice>
              <mc:Fallback>
                <p:oleObj name="Prism 6" r:id="rId3" imgW="3732086" imgH="4354262" progId="Prism6.Document">
                  <p:embed/>
                  <p:pic>
                    <p:nvPicPr>
                      <p:cNvPr id="19" name="Object 18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95048" y="989766"/>
                        <a:ext cx="2235465" cy="26082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71300250"/>
              </p:ext>
            </p:extLst>
          </p:nvPr>
        </p:nvGraphicFramePr>
        <p:xfrm>
          <a:off x="3748301" y="989765"/>
          <a:ext cx="2235465" cy="26082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7" name="Prism 6" r:id="rId5" imgW="3732086" imgH="4354262" progId="Prism6.Document">
                  <p:embed/>
                </p:oleObj>
              </mc:Choice>
              <mc:Fallback>
                <p:oleObj name="Prism 6" r:id="rId5" imgW="3732086" imgH="435426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48301" y="989765"/>
                        <a:ext cx="2235465" cy="26082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3430485"/>
              </p:ext>
            </p:extLst>
          </p:nvPr>
        </p:nvGraphicFramePr>
        <p:xfrm>
          <a:off x="6901554" y="1008745"/>
          <a:ext cx="2219198" cy="25892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8" name="Prism 6" r:id="rId7" imgW="3732086" imgH="4354262" progId="Prism6.Document">
                  <p:embed/>
                </p:oleObj>
              </mc:Choice>
              <mc:Fallback>
                <p:oleObj name="Prism 6" r:id="rId7" imgW="3732086" imgH="435426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901554" y="1008745"/>
                        <a:ext cx="2219198" cy="25892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6502373"/>
              </p:ext>
            </p:extLst>
          </p:nvPr>
        </p:nvGraphicFramePr>
        <p:xfrm>
          <a:off x="470298" y="4158081"/>
          <a:ext cx="2286436" cy="26999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89" name="Prism 6" r:id="rId9" imgW="3695713" imgH="4363626" progId="Prism6.Document">
                  <p:embed/>
                </p:oleObj>
              </mc:Choice>
              <mc:Fallback>
                <p:oleObj name="Prism 6" r:id="rId9" imgW="3695713" imgH="436362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70298" y="4158081"/>
                        <a:ext cx="2286436" cy="26999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6023061"/>
              </p:ext>
            </p:extLst>
          </p:nvPr>
        </p:nvGraphicFramePr>
        <p:xfrm>
          <a:off x="3748300" y="4145138"/>
          <a:ext cx="2235465" cy="27128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90" name="Prism 6" r:id="rId11" imgW="3695713" imgH="4354262" progId="Prism6.Document">
                  <p:embed/>
                </p:oleObj>
              </mc:Choice>
              <mc:Fallback>
                <p:oleObj name="Prism 6" r:id="rId11" imgW="3695713" imgH="4354262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748300" y="4145138"/>
                        <a:ext cx="2235465" cy="27128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/>
          <p:cNvSpPr txBox="1"/>
          <p:nvPr/>
        </p:nvSpPr>
        <p:spPr>
          <a:xfrm>
            <a:off x="6455142" y="4157448"/>
            <a:ext cx="541674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/>
              <a:t>Supplementary Figure 3 Minimum circulating complement concentrations not significantly different in the first 7 d after stroke</a:t>
            </a:r>
          </a:p>
          <a:p>
            <a:pPr algn="just"/>
            <a:r>
              <a:rPr lang="en-GB" sz="1400" dirty="0"/>
              <a:t>Minimum circulating concentration of C1q, C5, C9, C2, and C4b  measured in the first 7 d after stroke were not significantly different in both placebo and IL-1ra treated patients in comparison to healthy controls. Data show mean ±SD, one-way ANOVA with </a:t>
            </a:r>
            <a:r>
              <a:rPr lang="en-GB" sz="1400" dirty="0" err="1"/>
              <a:t>Bonferonni</a:t>
            </a:r>
            <a:r>
              <a:rPr lang="en-GB" sz="1400" dirty="0"/>
              <a:t> correction.</a:t>
            </a:r>
          </a:p>
        </p:txBody>
      </p:sp>
    </p:spTree>
    <p:extLst>
      <p:ext uri="{BB962C8B-B14F-4D97-AF65-F5344CB8AC3E}">
        <p14:creationId xmlns:p14="http://schemas.microsoft.com/office/powerpoint/2010/main" val="38727234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A38D13A-E8BF-4FE7-B3D5-87F66C4AF5F2}"/>
              </a:ext>
            </a:extLst>
          </p:cNvPr>
          <p:cNvSpPr txBox="1"/>
          <p:nvPr/>
        </p:nvSpPr>
        <p:spPr>
          <a:xfrm>
            <a:off x="273580" y="125874"/>
            <a:ext cx="5113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e4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5162991"/>
              </p:ext>
            </p:extLst>
          </p:nvPr>
        </p:nvGraphicFramePr>
        <p:xfrm>
          <a:off x="573969" y="869245"/>
          <a:ext cx="3149007" cy="29121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12" name="Prism 6" r:id="rId3" imgW="3841928" imgH="3552559" progId="Prism6.Document">
                  <p:embed/>
                </p:oleObj>
              </mc:Choice>
              <mc:Fallback>
                <p:oleObj name="Prism 6" r:id="rId3" imgW="3841928" imgH="3552559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73969" y="869245"/>
                        <a:ext cx="3149007" cy="29121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4039320" y="1436826"/>
            <a:ext cx="541674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/>
              <a:t>Supplementary Figure 4 Minimum circulating noradrenaline concentrations in the first 7 d after stroke</a:t>
            </a:r>
          </a:p>
          <a:p>
            <a:pPr algn="just"/>
            <a:r>
              <a:rPr lang="en-GB" sz="1400" dirty="0"/>
              <a:t>Minimum circulating concentration of noradrenaline measured in the first 7 d after stroke were not significantly different in both placebo and IL-1ra treated patients in comparison to healthy controls. Data show mean ±SD, one-way ANOVA with </a:t>
            </a:r>
            <a:r>
              <a:rPr lang="en-GB" sz="1400" dirty="0" err="1"/>
              <a:t>Bonferonni</a:t>
            </a:r>
            <a:r>
              <a:rPr lang="en-GB" sz="1400" dirty="0"/>
              <a:t> correction.</a:t>
            </a:r>
          </a:p>
        </p:txBody>
      </p:sp>
    </p:spTree>
    <p:extLst>
      <p:ext uri="{BB962C8B-B14F-4D97-AF65-F5344CB8AC3E}">
        <p14:creationId xmlns:p14="http://schemas.microsoft.com/office/powerpoint/2010/main" val="6955339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01360985"/>
              </p:ext>
            </p:extLst>
          </p:nvPr>
        </p:nvGraphicFramePr>
        <p:xfrm>
          <a:off x="1319942" y="558143"/>
          <a:ext cx="4606101" cy="5312402"/>
        </p:xfrm>
        <a:graphic>
          <a:graphicData uri="http://schemas.openxmlformats.org/drawingml/2006/table">
            <a:tbl>
              <a:tblPr firstRow="1" firstCol="1" bandRow="1"/>
              <a:tblGrid>
                <a:gridCol w="239410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2792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8407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20643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7168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lacebo (n=17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60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-1Ra</a:t>
                      </a: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  </a:t>
                      </a: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n=17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tient Demographics</a:t>
                      </a:r>
                      <a:endParaRPr lang="en-GB" sz="10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71976229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dian age (years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4 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1 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70 years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 (47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 (41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1361948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gt;70 years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 (53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</a:t>
                      </a:r>
                      <a:r>
                        <a:rPr lang="en-GB" sz="1000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59%</a:t>
                      </a: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0291133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ale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 (41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 (59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hite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 (100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 (88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5371965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MI (kg/m</a:t>
                      </a:r>
                      <a:r>
                        <a:rPr lang="en-GB" sz="1000" b="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) mean (SD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6 (4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6 (3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4432606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7661614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dian</a:t>
                      </a:r>
                      <a:r>
                        <a:rPr lang="en-GB" sz="1000" b="1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o</a:t>
                      </a: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set to</a:t>
                      </a:r>
                      <a:r>
                        <a:rPr lang="en-GB" sz="1000" b="1" baseline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treatment (hours)</a:t>
                      </a:r>
                      <a:endParaRPr lang="en-GB" sz="10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6 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6 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3174003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 4h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 (59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 (53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0578022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gt;4h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 (41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 (47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6102568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0849522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roke</a:t>
                      </a:r>
                      <a:r>
                        <a:rPr lang="en-GB" sz="1000" b="1" baseline="0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severity and subtype</a:t>
                      </a:r>
                      <a:endParaRPr lang="en-GB" sz="10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9952578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dian baseline NIHSS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1171022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-9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17.6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17.6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4797300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-20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 (70.6%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 (64.7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2048232"/>
                  </a:ext>
                </a:extLst>
              </a:tr>
              <a:tr h="207954"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≥21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11.8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17.6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4661611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schemic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 (100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 (70.6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3293832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aemorrhagic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 (0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 (29.4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8803654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3655821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b="1" dirty="0" smtClean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isk Factors</a:t>
                      </a:r>
                      <a:endParaRPr lang="en-GB" sz="10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9596788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urrent or former smoker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 (52.9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 (52.9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ypertension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 (52.9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 (52.9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trial fibrillation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17.6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17.6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iabetes mellitus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 (0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11.8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schaemic heart disease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23.5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 (29.4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9858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revious stroke or TIA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23.5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11.8%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3491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dian total cholesterol (mmol/l)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4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2</a:t>
                      </a:r>
                    </a:p>
                  </a:txBody>
                  <a:tcPr marL="38576" marR="3857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6433809" y="2000624"/>
            <a:ext cx="4179301" cy="82138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51435" tIns="25718" rIns="51435" bIns="25718" numCol="1" anchor="ctr" anchorCtr="0" compatLnSpc="1">
            <a:prstTxWarp prst="textNoShape">
              <a:avLst/>
            </a:prstTxWarp>
            <a:spAutoFit/>
          </a:bodyPr>
          <a:lstStyle/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en-US" sz="10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e1</a:t>
            </a:r>
            <a:endParaRPr lang="en-GB" altLang="en-US" sz="1000" b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seline characteristics of stroke patients treated with placebo or IL-1Ra</a:t>
            </a:r>
            <a:r>
              <a:rPr lang="en-GB" alt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 </a:t>
            </a:r>
            <a:r>
              <a:rPr lang="en-GB" alt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l data as n (%), unless specified.</a:t>
            </a:r>
            <a:endParaRPr lang="en-GB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defTabSz="51435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GB" alt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IHSS</a:t>
            </a:r>
            <a:r>
              <a:rPr lang="en-GB" alt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National Institutes of Health Stroke Scale</a:t>
            </a:r>
            <a:r>
              <a:rPr lang="en-GB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GB" altLang="en-US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IA </a:t>
            </a:r>
            <a:r>
              <a:rPr lang="en-GB" alt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ansient ischemic attack</a:t>
            </a:r>
            <a:endParaRPr lang="en-GB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829498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95</TotalTime>
  <Words>584</Words>
  <Application>Microsoft Office PowerPoint</Application>
  <PresentationFormat>Widescreen</PresentationFormat>
  <Paragraphs>120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.mcculloch@roslin.ed.ac.uk</dc:creator>
  <cp:lastModifiedBy>MCCULLOCH Laura</cp:lastModifiedBy>
  <cp:revision>85</cp:revision>
  <dcterms:created xsi:type="dcterms:W3CDTF">2018-03-19T21:39:17Z</dcterms:created>
  <dcterms:modified xsi:type="dcterms:W3CDTF">2019-03-11T15:30:41Z</dcterms:modified>
</cp:coreProperties>
</file>